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444" y="-1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1331B-2245-4AA9-BB9C-2A2F8FF9865C}" type="datetimeFigureOut">
              <a:rPr lang="en-US" smtClean="0"/>
              <a:t>10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49CBF-B19D-4580-AB22-5DD64F1A2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387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1331B-2245-4AA9-BB9C-2A2F8FF9865C}" type="datetimeFigureOut">
              <a:rPr lang="en-US" smtClean="0"/>
              <a:t>10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49CBF-B19D-4580-AB22-5DD64F1A2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6552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1331B-2245-4AA9-BB9C-2A2F8FF9865C}" type="datetimeFigureOut">
              <a:rPr lang="en-US" smtClean="0"/>
              <a:t>10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49CBF-B19D-4580-AB22-5DD64F1A2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819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1331B-2245-4AA9-BB9C-2A2F8FF9865C}" type="datetimeFigureOut">
              <a:rPr lang="en-US" smtClean="0"/>
              <a:t>10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49CBF-B19D-4580-AB22-5DD64F1A2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997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1331B-2245-4AA9-BB9C-2A2F8FF9865C}" type="datetimeFigureOut">
              <a:rPr lang="en-US" smtClean="0"/>
              <a:t>10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49CBF-B19D-4580-AB22-5DD64F1A2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938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1331B-2245-4AA9-BB9C-2A2F8FF9865C}" type="datetimeFigureOut">
              <a:rPr lang="en-US" smtClean="0"/>
              <a:t>10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49CBF-B19D-4580-AB22-5DD64F1A2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724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1331B-2245-4AA9-BB9C-2A2F8FF9865C}" type="datetimeFigureOut">
              <a:rPr lang="en-US" smtClean="0"/>
              <a:t>10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49CBF-B19D-4580-AB22-5DD64F1A2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795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1331B-2245-4AA9-BB9C-2A2F8FF9865C}" type="datetimeFigureOut">
              <a:rPr lang="en-US" smtClean="0"/>
              <a:t>10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49CBF-B19D-4580-AB22-5DD64F1A2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738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1331B-2245-4AA9-BB9C-2A2F8FF9865C}" type="datetimeFigureOut">
              <a:rPr lang="en-US" smtClean="0"/>
              <a:t>10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49CBF-B19D-4580-AB22-5DD64F1A2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177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1331B-2245-4AA9-BB9C-2A2F8FF9865C}" type="datetimeFigureOut">
              <a:rPr lang="en-US" smtClean="0"/>
              <a:t>10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49CBF-B19D-4580-AB22-5DD64F1A2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832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1331B-2245-4AA9-BB9C-2A2F8FF9865C}" type="datetimeFigureOut">
              <a:rPr lang="en-US" smtClean="0"/>
              <a:t>10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49CBF-B19D-4580-AB22-5DD64F1A2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6551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1331B-2245-4AA9-BB9C-2A2F8FF9865C}" type="datetimeFigureOut">
              <a:rPr lang="en-US" smtClean="0"/>
              <a:t>10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849CBF-B19D-4580-AB22-5DD64F1A2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2486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9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9800" y="76200"/>
            <a:ext cx="4005743" cy="571500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381000" y="5791200"/>
            <a:ext cx="81534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Additional Figure </a:t>
            </a:r>
            <a:r>
              <a:rPr lang="en-US" sz="1200" b="1" dirty="0" smtClean="0"/>
              <a:t>1: </a:t>
            </a:r>
            <a:r>
              <a:rPr lang="en-US" sz="1200" dirty="0" smtClean="0"/>
              <a:t>Binary </a:t>
            </a:r>
            <a:r>
              <a:rPr lang="en-US" sz="1200" dirty="0"/>
              <a:t>predictions made by 18 algorithms for each pathogenic or benign variants in </a:t>
            </a:r>
            <a:r>
              <a:rPr lang="en-US" sz="1200" dirty="0" err="1"/>
              <a:t>ClinVar</a:t>
            </a:r>
            <a:r>
              <a:rPr lang="en-US" sz="1200" dirty="0"/>
              <a:t> are shown in upper and lower panel respectively. Each variant is along a row and an orange and a green tile depicts a pathogenic or benign call by the corresponding algorithm, respectively. 8386 variants with </a:t>
            </a:r>
            <a:r>
              <a:rPr lang="en-US" sz="1200" dirty="0" err="1"/>
              <a:t>ClinVar</a:t>
            </a:r>
            <a:r>
              <a:rPr lang="en-US" sz="1200" dirty="0"/>
              <a:t> review status one star or above (A) and 1318 variants with </a:t>
            </a:r>
            <a:r>
              <a:rPr lang="en-US" sz="1200" dirty="0" err="1"/>
              <a:t>ClinVar</a:t>
            </a:r>
            <a:r>
              <a:rPr lang="en-US" sz="1200" dirty="0"/>
              <a:t> review status two star or above (B) are shown.</a:t>
            </a:r>
          </a:p>
        </p:txBody>
      </p:sp>
    </p:spTree>
    <p:extLst>
      <p:ext uri="{BB962C8B-B14F-4D97-AF65-F5344CB8AC3E}">
        <p14:creationId xmlns:p14="http://schemas.microsoft.com/office/powerpoint/2010/main" val="24730323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600" y="685800"/>
            <a:ext cx="7225284" cy="6108192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533400" y="5562600"/>
            <a:ext cx="4572000" cy="83099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b="1" dirty="0"/>
              <a:t>Additional Figure 2</a:t>
            </a:r>
            <a:r>
              <a:rPr lang="en-US" sz="1200" dirty="0"/>
              <a:t>: </a:t>
            </a:r>
            <a:r>
              <a:rPr lang="en-US" sz="1200" dirty="0" smtClean="0"/>
              <a:t>Performance </a:t>
            </a:r>
            <a:r>
              <a:rPr lang="en-US" sz="1200" dirty="0"/>
              <a:t>is measured using AUC and depicted along the y axis. The algorithms are sorted by their performance and the datasets the color coded as outlined in the legend. The horizontal dotted red line shows an AUC of 0.8.</a:t>
            </a:r>
          </a:p>
        </p:txBody>
      </p:sp>
    </p:spTree>
    <p:extLst>
      <p:ext uri="{BB962C8B-B14F-4D97-AF65-F5344CB8AC3E}">
        <p14:creationId xmlns:p14="http://schemas.microsoft.com/office/powerpoint/2010/main" val="12774881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" y="127243"/>
            <a:ext cx="9067800" cy="5816357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76200" y="6019800"/>
            <a:ext cx="9067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Additional Figure 3</a:t>
            </a:r>
            <a:r>
              <a:rPr lang="en-US" sz="1200" dirty="0"/>
              <a:t>: Performance analysis of algorithms. The AUC of a ROC are plotted for 25 algorithms. Vertical dotted line indicates a AUC of 0.9 and 99% confidence intervals for each AUC are shown. AUCs of the algorithms across four different datasets (represented in panels) to address type II circularity as described in text.</a:t>
            </a:r>
          </a:p>
        </p:txBody>
      </p:sp>
    </p:spTree>
    <p:extLst>
      <p:ext uri="{BB962C8B-B14F-4D97-AF65-F5344CB8AC3E}">
        <p14:creationId xmlns:p14="http://schemas.microsoft.com/office/powerpoint/2010/main" val="7006741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91</Words>
  <Application>Microsoft Office PowerPoint</Application>
  <PresentationFormat>On-screen Show (4:3)</PresentationFormat>
  <Paragraphs>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hosh, Rajarshi</dc:creator>
  <cp:lastModifiedBy>Ghosh, Rajarshi</cp:lastModifiedBy>
  <cp:revision>1</cp:revision>
  <dcterms:created xsi:type="dcterms:W3CDTF">2017-10-12T17:35:51Z</dcterms:created>
  <dcterms:modified xsi:type="dcterms:W3CDTF">2017-10-12T17:43:37Z</dcterms:modified>
</cp:coreProperties>
</file>